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240" y="60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772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76983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529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71550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09763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41701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46859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28704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1031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4764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60604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297E9-3BAB-473D-AF9E-8A505542F1A6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95587-19B9-46B2-B545-0EADA5606798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45526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876501"/>
              </p:ext>
            </p:extLst>
          </p:nvPr>
        </p:nvGraphicFramePr>
        <p:xfrm>
          <a:off x="342899" y="506914"/>
          <a:ext cx="6172201" cy="5734635"/>
        </p:xfrm>
        <a:graphic>
          <a:graphicData uri="http://schemas.openxmlformats.org/drawingml/2006/table">
            <a:tbl>
              <a:tblPr/>
              <a:tblGrid>
                <a:gridCol w="441693"/>
                <a:gridCol w="517609"/>
                <a:gridCol w="2650159"/>
                <a:gridCol w="517609"/>
                <a:gridCol w="517609"/>
                <a:gridCol w="763761"/>
                <a:gridCol w="763761"/>
              </a:tblGrid>
              <a:tr h="117456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CH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3 Table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7456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 50 most dysregulated genes in mEH KO vs WT liver ranked by fdr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103638"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H KO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10547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nk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g2 Ratio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unts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frc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ansferrin recepto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3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8E-2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9.9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78.3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fi202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terferon activated gene 202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2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5E-2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3.2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cl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 cell leukemia/lymphoma 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8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02E-2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4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8.7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mn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rmin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0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8E-2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3.8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.7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pk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omeodomain interacting protein kinase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3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2E-2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1.5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8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phx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poxide hydrolase 1, microsomal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2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27E-2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08.8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33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if13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inesin family member 13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1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84E-1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0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4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mpr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one morphogenetic protein receptor, type II (serine/threonine kinase)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8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45E-1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3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9.6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cp4l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urkinje cell protein 4-like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1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17E-1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8.8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.2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a, polypeptide 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5.7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46E-1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.4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8.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btb1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inc finger and BTB domain containing 1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6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5E-1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.6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2.5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mbrd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MBR1 domain containing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5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29E-1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1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88.7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ikfyve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osphoinositide kinase, FYVE finger containing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3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7E-1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.6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8.2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pcs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rum amyloid P-component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8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69E-1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34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10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tch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ched homolog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1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7E-1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.3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7.3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h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philin 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9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57E-1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1.3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0.8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kn1a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clin-dependent kinase inhibitor 1A (P21)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8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84E-1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.8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7.0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1a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1, member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1.0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4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8.4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p1g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daptor protein complex AP-1, gamma 1 subunit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5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3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5.5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54.6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npep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ucyl/cystinyl aminopeptidase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3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7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.7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8.4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fp44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inc finger protein 44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5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7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1.7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7.8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tb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yntrophin, basic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85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5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6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pam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erol-3-phosphate acyltransferase, mitochondrial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9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43E-1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37.0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01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bhd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bhydrolase domain containing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4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7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5.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04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p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jor urinary protein 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1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6733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7133.3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10a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10 (sodium/bile acid cotransporter family), member 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8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47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2.8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06.1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dp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yruvate dehydrogenase phosphatase regulatory subunit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0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1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1.3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5.9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st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ystonin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35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9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10.0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lld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lladin, cytoskeletal associated protein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8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7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9.3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9.2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c, polypeptide 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2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7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4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26.5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c, polypeptide 6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8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60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3.2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4.5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reb3l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MP responsive element binding protein 3-like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71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1.7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7.5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rp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steine and glycine-rich protein 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31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84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2.1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ta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utathione S-transferase, alpha 1 (Ya)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6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84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8.0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3.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p3k1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togen-activated protein kinase kinase kinase 1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9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68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.5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9.4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pnm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oprotein (transmembrane) nmb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8.8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68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5.2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p85l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ntrosomal protein 85-like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2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75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.4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8.2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sal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S protein activator like 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5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85E-1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.76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5.7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krd5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kyrin repeat domain 5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6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4.4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9.5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poa2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polipoprotein A-II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7033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193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rpina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rine (or cysteine) peptidase inhibito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1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73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3.0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co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igand dependent nuclear receptor corepressor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4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94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.1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8.5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hrs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hydrogenase/reductase (SDR family) member 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0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3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.1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6.4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sp9x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biquitin specific peptidase 9, X chromosome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4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2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7.3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25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para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oxisome proliferator activated receptor alpha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7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92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4.6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3.4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std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iosulfate sulfurtransferase (rhodanese)-like domain containing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48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1.6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6.9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od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OD1 OTU deubiquitinating enzyme 1 homologue (S. cerevisiae)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75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4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9.7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0.6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ik3ap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osphoinositide-3-kinase adaptor protein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2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1.33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11.8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tbd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TB (POZ) domain containing 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14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5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.78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0.9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3638"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iod circadian clock 1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8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35E-09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.20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9.67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3638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 false discovery rate </a:t>
                      </a:r>
                    </a:p>
                  </a:txBody>
                  <a:tcPr marL="6909" marR="6909" marT="690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909" marR="6909" marT="690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19637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9</Words>
  <Application>Microsoft Office PowerPoint</Application>
  <PresentationFormat>On-screen Show (4:3)</PresentationFormat>
  <Paragraphs>3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ät Züri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Morowsky</dc:creator>
  <cp:lastModifiedBy>Anne Morowsky</cp:lastModifiedBy>
  <cp:revision>1</cp:revision>
  <dcterms:created xsi:type="dcterms:W3CDTF">2017-09-26T13:21:00Z</dcterms:created>
  <dcterms:modified xsi:type="dcterms:W3CDTF">2017-09-26T13:30:50Z</dcterms:modified>
</cp:coreProperties>
</file>